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TH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512"/>
    <p:restoredTop sz="95794"/>
  </p:normalViewPr>
  <p:slideViewPr>
    <p:cSldViewPr snapToGrid="0">
      <p:cViewPr varScale="1">
        <p:scale>
          <a:sx n="111" d="100"/>
          <a:sy n="111" d="100"/>
        </p:scale>
        <p:origin x="40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3B8586-584C-7016-8C54-AA1CA79D1D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4792307-70B9-77EA-CC78-A8E3CD01E88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E00916-C635-5DAE-4D72-A5F123C81B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1A46-CFD9-4749-8487-132746A33378}" type="datetimeFigureOut">
              <a:rPr lang="en-TH" smtClean="0"/>
              <a:t>29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D4EED4-9E93-B38D-57CB-7340AB5756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42AE8D-6ABC-0256-E77A-9299DF860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343F-063D-014C-AF56-0B9E44B2D123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5048641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D81169-5C03-1A9C-38BA-2579F5E984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049E0A4-7F04-05BE-171B-5C951BC4D9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E55312-D89A-6D51-34FF-DE6AF648DE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1A46-CFD9-4749-8487-132746A33378}" type="datetimeFigureOut">
              <a:rPr lang="en-TH" smtClean="0"/>
              <a:t>29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93E431-22EC-585B-3E7E-787FD39E22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F7B9D8-6B36-F88C-89AC-4F4390C93A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343F-063D-014C-AF56-0B9E44B2D123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46930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3832622-7413-4D58-D79D-5D44A1FD217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795E79-D42B-4B81-8EC9-D0EDEA190C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084A56-CB11-0664-A826-7546FBFEF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1A46-CFD9-4749-8487-132746A33378}" type="datetimeFigureOut">
              <a:rPr lang="en-TH" smtClean="0"/>
              <a:t>29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964959-9E7C-0DC4-CA9E-B75717746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DD9918-DB02-6810-7331-B1FCD96EB4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343F-063D-014C-AF56-0B9E44B2D123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4179788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BA55F4-178A-48B8-BFAA-10A3D0A9F2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389368-3A78-CB76-043A-1F8CE1CDB1D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A53543-2020-83DE-1851-1046AD67D1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1A46-CFD9-4749-8487-132746A33378}" type="datetimeFigureOut">
              <a:rPr lang="en-TH" smtClean="0"/>
              <a:t>29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3E8A44-FC97-9954-98F0-C41161C693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D1819F-F3AE-DBDD-08C3-9C1DA86821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343F-063D-014C-AF56-0B9E44B2D123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7112163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32FA0C-D690-AA21-4691-917CAFB35B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D703C9-2E08-A55D-2519-4288C62BE0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EF6337-889C-2ECC-15EA-FAE575FAB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1A46-CFD9-4749-8487-132746A33378}" type="datetimeFigureOut">
              <a:rPr lang="en-TH" smtClean="0"/>
              <a:t>29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0FF921-C7D1-CC33-F16D-6A277E36B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22F1CB-8976-EEAC-CA1E-9F9BC4DBA0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343F-063D-014C-AF56-0B9E44B2D123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4029448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86967F-A30B-EC3A-1CCE-CD2A141D76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D6BCD9-39AB-739B-CCCA-22296747AD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14B6A7-F560-022A-D18F-255B58B21F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EBEDA7-ECE2-F670-9D10-908EC5DDB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1A46-CFD9-4749-8487-132746A33378}" type="datetimeFigureOut">
              <a:rPr lang="en-TH" smtClean="0"/>
              <a:t>29/12/2023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1AC68D-2273-1EBC-FCE8-632CC58321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AB581D-B56F-6D6C-65C7-D489DF8C87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343F-063D-014C-AF56-0B9E44B2D123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7493164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002158-8507-1AF2-BF1B-D5D29FFDE7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133CB7-7AE0-5EE7-E39F-C5F88EE5B8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722EDA-4C27-337F-9704-8ECF402047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110101A-66AE-B6C2-E894-868D294775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91E5BAD-6A4B-4214-B750-1F297B826B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468599D-BC34-6E12-5F31-2C949A77C9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1A46-CFD9-4749-8487-132746A33378}" type="datetimeFigureOut">
              <a:rPr lang="en-TH" smtClean="0"/>
              <a:t>29/12/2023 R</a:t>
            </a:fld>
            <a:endParaRPr lang="en-T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D74B591-7290-9CD0-E08E-C433A82B4F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D704E5D-328B-65BF-69B4-0016CBB3C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343F-063D-014C-AF56-0B9E44B2D123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6130725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67475A-F9D6-D661-1479-B26C787446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422CAE0-5B39-29CB-C4E7-C639A4FBFD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1A46-CFD9-4749-8487-132746A33378}" type="datetimeFigureOut">
              <a:rPr lang="en-TH" smtClean="0"/>
              <a:t>29/12/2023 R</a:t>
            </a:fld>
            <a:endParaRPr lang="en-T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C48F968-B388-4273-1A4A-00C6863FD9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510D2F-B066-1C03-002B-82875B1B11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343F-063D-014C-AF56-0B9E44B2D123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497498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5DB6C2C-D857-62B2-DC6A-A66BF9E762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1A46-CFD9-4749-8487-132746A33378}" type="datetimeFigureOut">
              <a:rPr lang="en-TH" smtClean="0"/>
              <a:t>29/12/2023 R</a:t>
            </a:fld>
            <a:endParaRPr lang="en-T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F56008E-AD0B-B6E3-5D32-A0D05F7310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8989FBB-E723-88B3-C374-2F24D54DC4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343F-063D-014C-AF56-0B9E44B2D123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634136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CF650A-97C9-C730-94CC-B0D74F5B71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7198B9-21D8-284B-EF18-3C77C008A1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723A25-52C0-E3EE-408E-B151788CBE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50039C-DD51-9B2A-323A-BAB90DD2D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1A46-CFD9-4749-8487-132746A33378}" type="datetimeFigureOut">
              <a:rPr lang="en-TH" smtClean="0"/>
              <a:t>29/12/2023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21B315-BE8B-E4AA-BD24-5E0C5E5931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0343BD-9E21-D4FF-BB79-546ACFFF0C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343F-063D-014C-AF56-0B9E44B2D123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388946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0B4367-56F9-3C85-F2AC-5F7D7F7E06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CE66A50-BB9C-E71C-1D42-3407C78706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653671-C69F-89F1-F1F9-7175C2F7C1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C45DF1-A9BE-3798-C5CE-F3C15EB4E7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E01A46-CFD9-4749-8487-132746A33378}" type="datetimeFigureOut">
              <a:rPr lang="en-TH" smtClean="0"/>
              <a:t>29/12/2023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2178B-166B-FC4D-F8AF-04DAA906A7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E53DBE-CAC9-D4AE-A189-4D41EFB64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343F-063D-014C-AF56-0B9E44B2D123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082321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1BD5831-4979-739C-D72D-B43C9698D2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4067FA-F0E3-AAD8-D780-31E5B84C61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BBE442-B2DA-EE1D-291D-ED88EA8AB9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E01A46-CFD9-4749-8487-132746A33378}" type="datetimeFigureOut">
              <a:rPr lang="en-TH" smtClean="0"/>
              <a:t>29/12/2023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59B756-C27E-4211-BCB5-170ADDD6ED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5A3B57-37DF-17FD-2B58-53B66D885B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84343F-063D-014C-AF56-0B9E44B2D123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969368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TH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hyperlink" Target="https://doi.org/10.1016/B978-0-12-407720-1.00002-9" TargetMode="Externa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12F6481-6D4F-F6F2-7401-CAC948F9024D}"/>
              </a:ext>
            </a:extLst>
          </p:cNvPr>
          <p:cNvSpPr txBox="1"/>
          <p:nvPr/>
        </p:nvSpPr>
        <p:spPr>
          <a:xfrm>
            <a:off x="0" y="1985944"/>
            <a:ext cx="12192000" cy="7397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TH" sz="3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12: Figure S7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65F4FD2-B99E-76B7-A800-A61175823309}"/>
              </a:ext>
            </a:extLst>
          </p:cNvPr>
          <p:cNvSpPr txBox="1"/>
          <p:nvPr/>
        </p:nvSpPr>
        <p:spPr>
          <a:xfrm>
            <a:off x="0" y="3164970"/>
            <a:ext cx="12191999" cy="6588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Examples of </a:t>
            </a:r>
            <a:r>
              <a:rPr lang="en-TH" sz="2800" b="1" i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. viverrini</a:t>
            </a:r>
            <a:r>
              <a:rPr lang="en-TH" sz="28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like egg </a:t>
            </a: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morphology</a:t>
            </a:r>
            <a:endParaRPr lang="en-TH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3781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A56B8C3F-2292-6923-F7DC-9A56CDDBF4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0266" y="806582"/>
            <a:ext cx="11611467" cy="48816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5A69903-FD72-1761-C0D6-34A4C15F8418}"/>
              </a:ext>
            </a:extLst>
          </p:cNvPr>
          <p:cNvSpPr txBox="1"/>
          <p:nvPr/>
        </p:nvSpPr>
        <p:spPr>
          <a:xfrm>
            <a:off x="660297" y="5487073"/>
            <a:ext cx="10983837" cy="11546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itional File 12: Figure S7. </a:t>
            </a:r>
            <a:r>
              <a:rPr lang="en-US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amples of </a:t>
            </a:r>
            <a:r>
              <a:rPr lang="en-US" sz="1600" i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. </a:t>
            </a:r>
            <a:r>
              <a:rPr lang="en-US" sz="1600" i="1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iverrini</a:t>
            </a:r>
            <a:r>
              <a:rPr lang="en-US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like egg </a:t>
            </a:r>
            <a:r>
              <a:rPr lang="en-TH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orphology</a:t>
            </a:r>
            <a:r>
              <a:rPr lang="en-US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ere discovered in this study. </a:t>
            </a:r>
            <a:endParaRPr lang="en-TH" sz="16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6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</a:t>
            </a:r>
            <a:r>
              <a:rPr lang="en-US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 findings (Figures A</a:t>
            </a:r>
            <a:r>
              <a:rPr lang="en-US" sz="16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–</a:t>
            </a:r>
            <a:r>
              <a:rPr lang="en-US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) showed that it </a:t>
            </a:r>
            <a:r>
              <a:rPr lang="en-US" sz="16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as</a:t>
            </a:r>
            <a:r>
              <a:rPr lang="en-US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ifficult to identify for certainty that the eggs were </a:t>
            </a:r>
            <a:r>
              <a:rPr lang="en-US" sz="1600" i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. </a:t>
            </a:r>
            <a:r>
              <a:rPr lang="en-US" sz="1600" i="1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iverrini</a:t>
            </a:r>
            <a:r>
              <a:rPr lang="en-US" sz="1600" i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ggs</a:t>
            </a:r>
            <a:r>
              <a:rPr lang="en-US" sz="16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TH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Ref.). </a:t>
            </a:r>
            <a:r>
              <a:rPr lang="en-US" sz="16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</a:t>
            </a:r>
            <a:r>
              <a:rPr lang="en-US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ages were photographed using the Zeiss microscope software package ZEN 2012 (Zeiss)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F31AA19-220E-9879-D05B-4C9C058C626B}"/>
              </a:ext>
            </a:extLst>
          </p:cNvPr>
          <p:cNvSpPr txBox="1"/>
          <p:nvPr/>
        </p:nvSpPr>
        <p:spPr>
          <a:xfrm>
            <a:off x="0" y="615553"/>
            <a:ext cx="12192000" cy="40011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TH" sz="20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amples of </a:t>
            </a:r>
            <a:r>
              <a:rPr lang="en-TH" sz="2000" b="1" i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. viverrini</a:t>
            </a:r>
            <a:r>
              <a:rPr lang="en-TH" sz="20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like egg morphology </a:t>
            </a:r>
            <a:endParaRPr lang="en-TH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72301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8BA2BF9-060E-81C6-00CB-A3D0F657BA3C}"/>
              </a:ext>
            </a:extLst>
          </p:cNvPr>
          <p:cNvSpPr txBox="1"/>
          <p:nvPr/>
        </p:nvSpPr>
        <p:spPr>
          <a:xfrm>
            <a:off x="1380766" y="1027362"/>
            <a:ext cx="9338034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TH" sz="14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ferences</a:t>
            </a:r>
          </a:p>
          <a:p>
            <a:endParaRPr lang="en-TH" sz="1400" b="1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342900" indent="-342900">
              <a:buAutoNum type="arabicPeriod"/>
            </a:pPr>
            <a:r>
              <a:rPr lang="en-TH" sz="14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C: Centers for Disease Control and Prevention, DPDx-laboratory </a:t>
            </a:r>
            <a:r>
              <a:rPr lang="en-TH" sz="14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</a:t>
            </a:r>
            <a:r>
              <a:rPr lang="en-TH" sz="14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ntification of parasites of public </a:t>
            </a:r>
            <a:r>
              <a:rPr lang="en-TH" sz="14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</a:t>
            </a:r>
            <a:r>
              <a:rPr lang="en-TH" sz="14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alth </a:t>
            </a:r>
            <a:r>
              <a:rPr lang="en-TH" sz="14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TH" sz="14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ncern, opisthorchiasis. Accessed 19 July 2023. Available at: </a:t>
            </a:r>
            <a:r>
              <a:rPr lang="en-US" sz="14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ttps://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ww.cdc.gov</a:t>
            </a:r>
            <a:r>
              <a:rPr lang="en-US" sz="14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pdx</a:t>
            </a:r>
            <a:r>
              <a:rPr lang="en-US" sz="14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pisthorchiasis</a:t>
            </a:r>
            <a:r>
              <a:rPr lang="en-US" sz="14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</a:t>
            </a:r>
            <a:r>
              <a:rPr lang="en-US" sz="14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dex.html</a:t>
            </a:r>
            <a:r>
              <a:rPr lang="en-US" sz="14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#:~:text=Eggs%20of%20Opisthorchis%20spp.&amp;text=are%2019%2D30%20µm%20long,embryonated%20when%20passed%20in%20feces.</a:t>
            </a:r>
          </a:p>
          <a:p>
            <a:pPr marL="342900" indent="-342900">
              <a:buFontTx/>
              <a:buAutoNum type="arabicPeriod"/>
            </a:pP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Waikagul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J &amp;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Thaenkham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U. </a:t>
            </a:r>
            <a:r>
              <a:rPr lang="en-US" sz="1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hapter 2 - Collection of fish-borne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matodes from the final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ost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pproaches to research on the systematics of fish-borne trematodes. </a:t>
            </a:r>
            <a:r>
              <a:rPr lang="en-US" sz="1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Academic Press. Amsterdam.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2014. </a:t>
            </a:r>
            <a:r>
              <a:rPr lang="en-US" sz="1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TH" sz="1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17-37. 978-0-12-407720-1. </a:t>
            </a:r>
            <a:r>
              <a:rPr lang="en-US" sz="1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https://doi.org/10.1016/B978-0-12-407720-1.00002-</a:t>
            </a:r>
            <a:r>
              <a:rPr lang="en-US" sz="1400" dirty="0">
                <a:effectLst/>
                <a:latin typeface="Arial" panose="020B0604020202020204" pitchFamily="34" charset="0"/>
                <a:cs typeface="Arial" panose="020B0604020202020204" pitchFamily="34" charset="0"/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9</a:t>
            </a:r>
            <a:endParaRPr lang="en-US" sz="14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>
              <a:buFontTx/>
              <a:buAutoNum type="arabicPeriod"/>
            </a:pP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ongsawad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,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halee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,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ikong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,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uboon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,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ithikathkul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. Co-infection with 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pisthorchis </a:t>
            </a:r>
            <a:r>
              <a:rPr lang="en-US" sz="14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iverrini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</a:t>
            </a:r>
            <a:r>
              <a:rPr lang="en-US" sz="14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aplorchis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ichui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tected by human fecal examination in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omtong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istrict, Chiang Mai Province, Thailand. Parasitology international.</a:t>
            </a:r>
            <a:r>
              <a:rPr lang="en-US" sz="14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012;61 1:56-9;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oi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https://doi.org/10.1016/j.parint.2011.10.003. https://www.sciencedirect.com/science/article/pii/S1383576911001486.</a:t>
            </a:r>
            <a:r>
              <a:rPr lang="en-TH" sz="1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4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397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</TotalTime>
  <Words>279</Words>
  <Application>Microsoft Macintosh PowerPoint</Application>
  <PresentationFormat>Widescreen</PresentationFormat>
  <Paragraphs>1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rawan Phuphisut</dc:creator>
  <cp:lastModifiedBy>Orawan Phuphisut</cp:lastModifiedBy>
  <cp:revision>21</cp:revision>
  <dcterms:created xsi:type="dcterms:W3CDTF">2023-08-09T07:06:59Z</dcterms:created>
  <dcterms:modified xsi:type="dcterms:W3CDTF">2023-12-29T04:41:49Z</dcterms:modified>
</cp:coreProperties>
</file>